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47" d="100"/>
          <a:sy n="47" d="100"/>
        </p:scale>
        <p:origin x="97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149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621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836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50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374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309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469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670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332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901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558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4CE6B5-3DAC-46B8-B1C2-DB8963489CB8}" type="datetimeFigureOut">
              <a:rPr lang="en-US" smtClean="0"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82706D-2885-4A96-BB48-53A0DF5EA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856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" name="Picture 13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5766" y="3311302"/>
            <a:ext cx="6600147" cy="3309042"/>
          </a:xfrm>
          <a:prstGeom prst="rect">
            <a:avLst/>
          </a:prstGeom>
        </p:spPr>
      </p:pic>
      <p:pic>
        <p:nvPicPr>
          <p:cNvPr id="138" name="Picture 13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5765" y="0"/>
            <a:ext cx="6600147" cy="33090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45369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77821" y="1344706"/>
            <a:ext cx="739963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 Concentration in GK an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Wistar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re statistically significant for that sex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† Concentration in male and female are statistically significant for that phenotype (compares to corresponding moiety in panels A &amp; B).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§ The ANOVA interaction term is statistically significant (compares corresponding moiety in panels A &amp; 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5486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3</Words>
  <Application>Microsoft Office PowerPoint</Application>
  <PresentationFormat>On-screen Show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oresh Shoghi</dc:creator>
  <cp:lastModifiedBy>Kooresh Shoghi</cp:lastModifiedBy>
  <cp:revision>2</cp:revision>
  <dcterms:created xsi:type="dcterms:W3CDTF">2016-03-23T04:36:19Z</dcterms:created>
  <dcterms:modified xsi:type="dcterms:W3CDTF">2016-03-23T04:39:01Z</dcterms:modified>
</cp:coreProperties>
</file>